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77724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C99C4-8E15-4AF7-91EE-6E95203D52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6172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4493880"/>
            <a:ext cx="6172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66423-3436-42E1-859C-2BE352599C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81440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449388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449388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D07D84-21BF-4813-8122-E7C5898D6F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1987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814400"/>
            <a:ext cx="1987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814400"/>
            <a:ext cx="1987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4493880"/>
            <a:ext cx="1987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4493880"/>
            <a:ext cx="1987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4493880"/>
            <a:ext cx="1987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2929B-C6E7-4848-849A-B8A13FFED6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814400"/>
            <a:ext cx="6172200" cy="512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26"/>
              </a:spcBef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4186B-6FA4-4648-8BC5-AC845BD5A0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6172200" cy="512928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C7F06-E3CF-4385-BCCD-2DD470C4FF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3011760" cy="512928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814400"/>
            <a:ext cx="3011760" cy="512928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97A5A-D09E-467A-A86A-5809895DB0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3DCE2-17D8-491A-AD57-721CFA4E1C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10680"/>
            <a:ext cx="6172200" cy="6006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26"/>
              </a:spcBef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03099-F919-44A4-A76E-3B7815B44D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814400"/>
            <a:ext cx="3011760" cy="512928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449388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EE135-41A1-4319-9789-0DA1429302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3011760" cy="512928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81440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449388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3D7B9-0F40-4AAC-AC63-7AA87E8608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81440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814400"/>
            <a:ext cx="301176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4493880"/>
            <a:ext cx="6172200" cy="24465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indent="0">
              <a:spcBef>
                <a:spcPts val="726"/>
              </a:spcBef>
              <a:buNone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A31BE-9C3B-44EA-9012-576AE17193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10680"/>
            <a:ext cx="6172200" cy="129564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 algn="ctr">
              <a:buNone/>
              <a:tabLst>
                <a:tab algn="l" pos="0"/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814400"/>
            <a:ext cx="6172200" cy="512928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t">
            <a:normAutofit/>
          </a:bodyPr>
          <a:p>
            <a:pPr marL="307800" indent="-307800"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1" marL="668160" indent="-25704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2" marL="1027080" indent="-204840"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3" marL="1440000" indent="-20664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4" marL="1851120" indent="-204840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5" marL="1851120" indent="-204840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  <a:p>
            <a:pPr lvl="6" marL="1851120" indent="-204840">
              <a:spcBef>
                <a:spcPts val="726"/>
              </a:spcBef>
              <a:buClr>
                <a:srgbClr val="000000"/>
              </a:buClr>
              <a:buFont typeface="Arial"/>
              <a:buChar char="»"/>
              <a:tabLst>
                <a:tab algn="l" pos="822240"/>
                <a:tab algn="l" pos="1644480"/>
                <a:tab algn="l" pos="2467080"/>
                <a:tab algn="l" pos="3289320"/>
                <a:tab algn="l" pos="4111560"/>
                <a:tab algn="l" pos="4933800"/>
                <a:tab algn="l" pos="5756400"/>
                <a:tab algn="l" pos="6578640"/>
                <a:tab algn="l" pos="7400880"/>
                <a:tab algn="l" pos="8223120"/>
                <a:tab algn="l" pos="9045720"/>
                <a:tab algn="l" pos="9867960"/>
                <a:tab algn="l" pos="106902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7203600"/>
            <a:ext cx="1600200" cy="4143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lstStyle>
            <a:lvl1pPr indent="0">
              <a:buNone/>
              <a:tabLst>
                <a:tab algn="l" pos="0"/>
                <a:tab algn="l" pos="615960"/>
                <a:tab algn="l" pos="1231920"/>
                <a:tab algn="l" pos="1847880"/>
                <a:tab algn="l" pos="2463840"/>
                <a:tab algn="l" pos="3079800"/>
                <a:tab algn="l" pos="3695760"/>
                <a:tab algn="l" pos="4311720"/>
                <a:tab algn="l" pos="4927680"/>
                <a:tab algn="l" pos="5543640"/>
                <a:tab algn="l" pos="6159600"/>
                <a:tab algn="l" pos="6775560"/>
                <a:tab algn="l" pos="7391520"/>
                <a:tab algn="l" pos="8007480"/>
                <a:tab algn="l" pos="8623440"/>
                <a:tab algn="l" pos="9239400"/>
                <a:tab algn="l" pos="9855360"/>
                <a:tab algn="l" pos="10471320"/>
              </a:tabLst>
              <a:defRPr b="0" lang="ja-JP" sz="11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615960"/>
                <a:tab algn="l" pos="1231920"/>
                <a:tab algn="l" pos="1847880"/>
                <a:tab algn="l" pos="2463840"/>
                <a:tab algn="l" pos="3079800"/>
                <a:tab algn="l" pos="3695760"/>
                <a:tab algn="l" pos="4311720"/>
                <a:tab algn="l" pos="4927680"/>
                <a:tab algn="l" pos="5543640"/>
                <a:tab algn="l" pos="6159600"/>
                <a:tab algn="l" pos="6775560"/>
                <a:tab algn="l" pos="7391520"/>
                <a:tab algn="l" pos="8007480"/>
                <a:tab algn="l" pos="8623440"/>
                <a:tab algn="l" pos="9239400"/>
                <a:tab algn="l" pos="9855360"/>
                <a:tab algn="l" pos="10471320"/>
              </a:tabLst>
            </a:pPr>
            <a:r>
              <a:rPr b="0" lang="ja-JP" sz="11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7203600"/>
            <a:ext cx="2171520" cy="4143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7203600"/>
            <a:ext cx="1600200" cy="414360"/>
          </a:xfrm>
          <a:prstGeom prst="rect">
            <a:avLst/>
          </a:prstGeom>
          <a:noFill/>
          <a:ln w="0">
            <a:noFill/>
          </a:ln>
        </p:spPr>
        <p:txBody>
          <a:bodyPr lIns="82440" rIns="82440" tIns="41040" bIns="41040" anchor="ctr">
            <a:noAutofit/>
          </a:bodyPr>
          <a:lstStyle>
            <a:lvl1pPr indent="0" algn="r">
              <a:buNone/>
              <a:tabLst>
                <a:tab algn="l" pos="0"/>
                <a:tab algn="l" pos="615960"/>
                <a:tab algn="l" pos="1231920"/>
                <a:tab algn="l" pos="1847880"/>
                <a:tab algn="l" pos="2463840"/>
                <a:tab algn="l" pos="3079800"/>
                <a:tab algn="l" pos="3695760"/>
                <a:tab algn="l" pos="4311720"/>
                <a:tab algn="l" pos="4927680"/>
                <a:tab algn="l" pos="5543640"/>
                <a:tab algn="l" pos="6159600"/>
                <a:tab algn="l" pos="6775560"/>
                <a:tab algn="l" pos="7391520"/>
                <a:tab algn="l" pos="8007480"/>
                <a:tab algn="l" pos="8623440"/>
                <a:tab algn="l" pos="9239400"/>
                <a:tab algn="l" pos="9855360"/>
                <a:tab algn="l" pos="10471320"/>
              </a:tabLst>
              <a:defRPr b="0" lang="ja-JP" sz="11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615960"/>
                <a:tab algn="l" pos="1231920"/>
                <a:tab algn="l" pos="1847880"/>
                <a:tab algn="l" pos="2463840"/>
                <a:tab algn="l" pos="3079800"/>
                <a:tab algn="l" pos="3695760"/>
                <a:tab algn="l" pos="4311720"/>
                <a:tab algn="l" pos="4927680"/>
                <a:tab algn="l" pos="5543640"/>
                <a:tab algn="l" pos="6159600"/>
                <a:tab algn="l" pos="6775560"/>
                <a:tab algn="l" pos="7391520"/>
                <a:tab algn="l" pos="8007480"/>
                <a:tab algn="l" pos="8623440"/>
                <a:tab algn="l" pos="9239400"/>
                <a:tab algn="l" pos="9855360"/>
                <a:tab algn="l" pos="10471320"/>
              </a:tabLst>
            </a:pPr>
            <a:fld id="{1C70A835-A423-430E-81F7-3A214A166533}" type="slidenum">
              <a:rPr b="0" lang="ja-JP" sz="11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タイトル 6"/>
          <p:cNvSpPr/>
          <p:nvPr/>
        </p:nvSpPr>
        <p:spPr>
          <a:xfrm>
            <a:off x="652320" y="291960"/>
            <a:ext cx="5842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2040" rIns="122040" tIns="61200" bIns="61200" anchor="ctr">
            <a:noAutofit/>
          </a:bodyPr>
          <a:p>
            <a:pPr marL="343080" indent="-3430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S1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44440" y="1062000"/>
            <a:ext cx="6400800" cy="6523920"/>
            <a:chOff x="244440" y="1062000"/>
            <a:chExt cx="6400800" cy="6523920"/>
          </a:xfrm>
        </p:grpSpPr>
        <p:sp>
          <p:nvSpPr>
            <p:cNvPr id="43" name="Text Box 9"/>
            <p:cNvSpPr/>
            <p:nvPr/>
          </p:nvSpPr>
          <p:spPr>
            <a:xfrm>
              <a:off x="624240" y="2390760"/>
              <a:ext cx="9914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lactin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Text Box 10"/>
            <p:cNvSpPr/>
            <p:nvPr/>
          </p:nvSpPr>
          <p:spPr>
            <a:xfrm>
              <a:off x="626040" y="3400200"/>
              <a:ext cx="9896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GFBP-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Text Box 25"/>
            <p:cNvSpPr/>
            <p:nvPr/>
          </p:nvSpPr>
          <p:spPr>
            <a:xfrm>
              <a:off x="792000" y="4294080"/>
              <a:ext cx="770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20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β-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actin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正方形/長方形 22"/>
            <p:cNvSpPr/>
            <p:nvPr/>
          </p:nvSpPr>
          <p:spPr>
            <a:xfrm>
              <a:off x="244440" y="5360760"/>
              <a:ext cx="6400800" cy="222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duction of Prolactin and IGFBP-1 expression in KC02-44D cells.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KC02-44D cells were treated with the indicated combinations of 10</a:t>
              </a:r>
              <a:r>
                <a:rPr b="0" lang="en-US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−8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 E2, 10</a:t>
              </a:r>
              <a:r>
                <a:rPr b="0" lang="en-US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−6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 MPA, and 0.125 mM cAMP for 6 days. Induction of transcripts for the decidualization markers prolactin and IGFBP-1 was demonstrated by RT-PCR; </a:t>
              </a:r>
              <a:r>
                <a:rPr b="0" lang="el-GR" sz="14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β-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n mRNA was amplified for normalization.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ssage number 17. The primers used for amplification were as follows: Prolactin, forward primer 5′-GAGCCTGATAGTCAGCATATTG-3′ and reverse primer 5′-TGGATGTGGGCTTAGCAGTTGT-3′; IGFBP-1, forward primer 5′- GAGAGCACGGAGATAACTGAGG -3′ and reverse primer 5′- AGGGATCCTCTTCCCATTCCAAGGGTAGA -3’.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Rectangle 55"/>
            <p:cNvSpPr/>
            <p:nvPr/>
          </p:nvSpPr>
          <p:spPr>
            <a:xfrm>
              <a:off x="2194560" y="10620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Rectangle 56"/>
            <p:cNvSpPr/>
            <p:nvPr/>
          </p:nvSpPr>
          <p:spPr>
            <a:xfrm>
              <a:off x="3355200" y="10620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Rectangle 57"/>
            <p:cNvSpPr/>
            <p:nvPr/>
          </p:nvSpPr>
          <p:spPr>
            <a:xfrm>
              <a:off x="2753280" y="10620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Rectangle 58"/>
            <p:cNvSpPr/>
            <p:nvPr/>
          </p:nvSpPr>
          <p:spPr>
            <a:xfrm>
              <a:off x="3942360" y="10620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Rectangle 57"/>
            <p:cNvSpPr/>
            <p:nvPr/>
          </p:nvSpPr>
          <p:spPr>
            <a:xfrm>
              <a:off x="4555080" y="10620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Rectangle 58"/>
            <p:cNvSpPr/>
            <p:nvPr/>
          </p:nvSpPr>
          <p:spPr>
            <a:xfrm>
              <a:off x="5177160" y="10620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Rectangle 55"/>
            <p:cNvSpPr/>
            <p:nvPr/>
          </p:nvSpPr>
          <p:spPr>
            <a:xfrm>
              <a:off x="2194560" y="13842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56"/>
            <p:cNvSpPr/>
            <p:nvPr/>
          </p:nvSpPr>
          <p:spPr>
            <a:xfrm>
              <a:off x="3323160" y="13842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Rectangle 57"/>
            <p:cNvSpPr/>
            <p:nvPr/>
          </p:nvSpPr>
          <p:spPr>
            <a:xfrm>
              <a:off x="2785320" y="13842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Rectangle 58"/>
            <p:cNvSpPr/>
            <p:nvPr/>
          </p:nvSpPr>
          <p:spPr>
            <a:xfrm>
              <a:off x="3942360" y="13842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Rectangle 57"/>
            <p:cNvSpPr/>
            <p:nvPr/>
          </p:nvSpPr>
          <p:spPr>
            <a:xfrm>
              <a:off x="4555080" y="13842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Rectangle 58"/>
            <p:cNvSpPr/>
            <p:nvPr/>
          </p:nvSpPr>
          <p:spPr>
            <a:xfrm>
              <a:off x="5209200" y="13842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Rectangle 55"/>
            <p:cNvSpPr/>
            <p:nvPr/>
          </p:nvSpPr>
          <p:spPr>
            <a:xfrm>
              <a:off x="2194560" y="17064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Rectangle 56"/>
            <p:cNvSpPr/>
            <p:nvPr/>
          </p:nvSpPr>
          <p:spPr>
            <a:xfrm>
              <a:off x="3355920" y="17064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Rectangle 57"/>
            <p:cNvSpPr/>
            <p:nvPr/>
          </p:nvSpPr>
          <p:spPr>
            <a:xfrm>
              <a:off x="2785320" y="17064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Rectangle 58"/>
            <p:cNvSpPr/>
            <p:nvPr/>
          </p:nvSpPr>
          <p:spPr>
            <a:xfrm>
              <a:off x="3974400" y="17064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57"/>
            <p:cNvSpPr/>
            <p:nvPr/>
          </p:nvSpPr>
          <p:spPr>
            <a:xfrm>
              <a:off x="4555080" y="17064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Rectangle 58"/>
            <p:cNvSpPr/>
            <p:nvPr/>
          </p:nvSpPr>
          <p:spPr>
            <a:xfrm>
              <a:off x="5177160" y="1706400"/>
              <a:ext cx="15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Rectangle 55"/>
            <p:cNvSpPr/>
            <p:nvPr/>
          </p:nvSpPr>
          <p:spPr>
            <a:xfrm>
              <a:off x="929880" y="1062000"/>
              <a:ext cx="311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2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Rectangle 55"/>
            <p:cNvSpPr/>
            <p:nvPr/>
          </p:nvSpPr>
          <p:spPr>
            <a:xfrm>
              <a:off x="930240" y="1384200"/>
              <a:ext cx="55080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PA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Rectangle 55"/>
            <p:cNvSpPr/>
            <p:nvPr/>
          </p:nvSpPr>
          <p:spPr>
            <a:xfrm>
              <a:off x="929880" y="1706400"/>
              <a:ext cx="6789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MP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68" name="Picture 17" descr=""/>
            <p:cNvPicPr/>
            <p:nvPr/>
          </p:nvPicPr>
          <p:blipFill>
            <a:blip r:embed="rId1"/>
            <a:stretch/>
          </p:blipFill>
          <p:spPr>
            <a:xfrm>
              <a:off x="1950840" y="2143080"/>
              <a:ext cx="3660840" cy="90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18" descr=""/>
            <p:cNvPicPr/>
            <p:nvPr/>
          </p:nvPicPr>
          <p:blipFill>
            <a:blip r:embed="rId2"/>
            <a:stretch/>
          </p:blipFill>
          <p:spPr>
            <a:xfrm>
              <a:off x="1950840" y="3108240"/>
              <a:ext cx="3660840" cy="90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19" descr=""/>
            <p:cNvPicPr/>
            <p:nvPr/>
          </p:nvPicPr>
          <p:blipFill>
            <a:blip r:embed="rId3"/>
            <a:stretch/>
          </p:blipFill>
          <p:spPr>
            <a:xfrm>
              <a:off x="1950840" y="4073400"/>
              <a:ext cx="3660840" cy="9032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9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12-04T05:57:58Z</dcterms:created>
  <dc:creator>NRRC Client</dc:creator>
  <dc:description/>
  <dc:language>en-US</dc:language>
  <cp:lastModifiedBy>Antonin</cp:lastModifiedBy>
  <cp:lastPrinted>2000-04-18T05:06:02Z</cp:lastPrinted>
  <dcterms:modified xsi:type="dcterms:W3CDTF">2011-07-22T20:07:56Z</dcterms:modified>
  <cp:revision>1342</cp:revision>
  <dc:subject/>
  <dc:title>ｽﾗｲﾄﾞ ﾀｲﾄﾙなし</dc:title>
</cp:coreProperties>
</file>